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246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2214465" y="5340436"/>
            <a:ext cx="864462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6. 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AST 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ALT 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evels of HepG2 and Hep-orgs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fter being treated with GNSs and GNBs (the black dots represent the number of samples). *P &lt; 0.05, **P &lt; 0.01, ***P &lt; 0.001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44B98B1-91D6-7BA8-C78C-A3296C6E64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8805" y="960443"/>
            <a:ext cx="9095942" cy="4225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1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8</cp:revision>
  <dcterms:created xsi:type="dcterms:W3CDTF">2023-11-27T11:36:49Z</dcterms:created>
  <dcterms:modified xsi:type="dcterms:W3CDTF">2024-02-07T14:15:31Z</dcterms:modified>
</cp:coreProperties>
</file>